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538" r:id="rId2"/>
    <p:sldId id="53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65"/>
    <p:restoredTop sz="95245"/>
  </p:normalViewPr>
  <p:slideViewPr>
    <p:cSldViewPr snapToGrid="0" snapToObjects="1">
      <p:cViewPr varScale="1">
        <p:scale>
          <a:sx n="114" d="100"/>
          <a:sy n="114" d="100"/>
        </p:scale>
        <p:origin x="6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564C46-8F56-E84F-92F4-2503BE4CAC76}" type="datetimeFigureOut">
              <a:rPr lang="en-US" smtClean="0"/>
              <a:t>12/7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ABB4F7-BA9E-0342-8FBF-530B9C9FB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139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DD0D38-6050-E44A-8E4F-338240D212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5F197E-3F48-8A4D-8053-542FCD4FBE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256B3D-16D7-FE46-AB7D-9013A0767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28CC7-3AA7-804C-BE7F-AED7730E3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24D23B-A76A-9143-98B5-C1B0FBE7E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655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93D978-5779-4740-9A4E-BDA3A7DDB9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30A75A-A90B-694C-B1D1-CE538B2C16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AB9D38-D833-D141-B92B-CC4BE7223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578D23-E2AF-7745-A0A7-F80C907F5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C460EF-44C1-A249-B080-F7CDD5DF7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287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614D27-54AA-834E-844F-5312CA9D8D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AC834F-16D3-F240-8A9C-27695C3EBA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9F54B3-0AF2-A647-BD3B-DAB9D7777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E18ABE-4572-C349-8F31-163E0274D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A248FE-DEDA-AB4D-9F0A-1C11D5094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997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71D69-B5C8-5445-AA9F-30A823302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C1E83F-9D5A-4242-89EC-6DD0CB0E51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12F343-FD09-984B-9E6A-271B56796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83DFFF-3819-5A49-B195-AFEDE4D9E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C50305-E260-C047-B3F8-F2572DD67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547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6A37D-0821-B047-B553-CAA8583EB0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4C5FB1-861F-0A43-BEE4-A5B2A5AC2B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602AA4-E082-3D4F-851B-F181804F7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22F22-4E14-3D46-BA59-2F1B5F0AC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353C14-8B5C-DC48-8969-22491AD4B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964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2457B5-193F-1248-B450-5274B82D96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D642AE-C1E6-BF41-944E-583E107441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B0B9C7-77E4-9D4C-9A66-88E3543C11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F1A698-3FD5-CD42-9857-1FA0A3E7A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D36D2D-BE12-9D4C-9C2D-70DD1ECD1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90A3D0-FC7A-0146-A083-0A6274D36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676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5CF3F4-704C-474B-856C-FA31009D32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B96B1A-92C3-1845-8543-D239609861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95907A-24E6-5345-B195-684C324AE9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77351DC-56FB-EC4C-9E13-8CF081F93E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8539FD-C24B-FA47-9A3B-2907DBF167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EBE1E9-BCF0-6643-9418-FE4531F07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3645F4-0825-8046-8884-68C5F5638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8A356E-35E5-4A45-BFD2-0F3916F42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332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18B95-8440-5F4B-BD8C-953F26752F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1AB9F1A-2BD0-5946-A02E-C958D414D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1C5CEC-3E0C-004A-B12B-8335A894C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411DF6-A6FE-9F45-A6ED-CCCBDF84B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370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37489E-11BB-4D42-9706-58520A341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2F715C5-7AEF-4A41-9EB1-1D3FE87CD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11BFE7-8F0F-2E49-AF4D-8907ABC24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394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D6D05F-1E7E-8946-B215-3AF4054798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AC4F9B-E919-D249-A157-A79B9F4CCD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01A1AB-F56B-F84F-BF75-D94C866D26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67BF4E-B213-4B44-9286-D9236E143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973138-3971-C444-961D-AF5C90732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D6C105-B962-DB48-9FFA-CC203DBA2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333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C5DAF-0089-804D-BDF7-F021A54BAA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EB7C77-8DE0-954D-A847-E66CEEBEAE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6850B8-4CD1-C24C-ADE6-794D7EDE5C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A2E648-68AD-4746-BE92-2F370803B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B40E55-194C-4443-A826-9935D0C0F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74CB24-F718-434A-9ABE-7B24D74AF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976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8B843B-061D-C149-BE22-7AB9CF74F8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D9C64F-5678-6944-AA65-E1507EA6FD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C70CCC-2F78-944C-B3AF-55F6B6A3D4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8A71B9-4FD3-EE49-82C0-CC0DCAD6684E}" type="datetimeFigureOut">
              <a:rPr lang="en-US" smtClean="0"/>
              <a:t>12/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E787EC-2ABD-2542-A702-0FA32A1201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A1791A-8678-A94C-86AD-BCEEAC0A59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A3479-C87C-3649-8304-E845505A67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263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4">
            <a:extLst>
              <a:ext uri="{FF2B5EF4-FFF2-40B4-BE49-F238E27FC236}">
                <a16:creationId xmlns:a16="http://schemas.microsoft.com/office/drawing/2014/main" id="{981C83C5-DBF4-4F4F-A2B6-814D7D8EFE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18047" y="1461890"/>
            <a:ext cx="47497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600" b="1" dirty="0">
                <a:latin typeface="Arial" panose="020B0604020202020204" pitchFamily="34" charset="0"/>
              </a:rPr>
              <a:t>A</a:t>
            </a:r>
            <a:endParaRPr kumimoji="0" lang="en-US" altLang="en-US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11F1621-AFB3-5245-B8D5-D4CBA6114F60}"/>
              </a:ext>
            </a:extLst>
          </p:cNvPr>
          <p:cNvSpPr/>
          <p:nvPr/>
        </p:nvSpPr>
        <p:spPr>
          <a:xfrm>
            <a:off x="4436332" y="407806"/>
            <a:ext cx="333686" cy="5031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B23B206-ED48-0E41-AA15-8686E7F14BC3}"/>
              </a:ext>
            </a:extLst>
          </p:cNvPr>
          <p:cNvSpPr txBox="1"/>
          <p:nvPr/>
        </p:nvSpPr>
        <p:spPr>
          <a:xfrm rot="16200000">
            <a:off x="-101168" y="1987971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10694E8-8750-5048-B82E-3EFD475052C6}"/>
              </a:ext>
            </a:extLst>
          </p:cNvPr>
          <p:cNvSpPr txBox="1"/>
          <p:nvPr/>
        </p:nvSpPr>
        <p:spPr>
          <a:xfrm rot="16200000">
            <a:off x="-101168" y="2867947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604FF9-4F26-9342-B0C0-C61201F10053}"/>
              </a:ext>
            </a:extLst>
          </p:cNvPr>
          <p:cNvSpPr txBox="1"/>
          <p:nvPr/>
        </p:nvSpPr>
        <p:spPr>
          <a:xfrm rot="16200000">
            <a:off x="-101168" y="359002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3</a:t>
            </a:r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id="{1AEA6010-BC35-234D-A13B-07226395A2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2742" y="1381547"/>
            <a:ext cx="47497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600" b="1" dirty="0">
                <a:latin typeface="Arial" panose="020B0604020202020204" pitchFamily="34" charset="0"/>
              </a:rPr>
              <a:t>B</a:t>
            </a:r>
            <a:endParaRPr kumimoji="0" lang="en-US" altLang="en-US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4CF77D-CC47-1A46-890E-D34E90DAFB50}"/>
              </a:ext>
            </a:extLst>
          </p:cNvPr>
          <p:cNvSpPr txBox="1"/>
          <p:nvPr/>
        </p:nvSpPr>
        <p:spPr>
          <a:xfrm rot="16200000">
            <a:off x="2661017" y="1922984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441110-D8B6-D446-AA4B-F5675D6DAD87}"/>
              </a:ext>
            </a:extLst>
          </p:cNvPr>
          <p:cNvSpPr txBox="1"/>
          <p:nvPr/>
        </p:nvSpPr>
        <p:spPr>
          <a:xfrm rot="16200000">
            <a:off x="2661017" y="2752619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C6D23BA-CFCF-BB4B-9233-4EC5A9B56B25}"/>
              </a:ext>
            </a:extLst>
          </p:cNvPr>
          <p:cNvSpPr txBox="1"/>
          <p:nvPr/>
        </p:nvSpPr>
        <p:spPr>
          <a:xfrm rot="16200000">
            <a:off x="2661017" y="3561401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5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A52DEAD-867C-1241-91E6-2873C0EEDCA4}"/>
              </a:ext>
            </a:extLst>
          </p:cNvPr>
          <p:cNvGrpSpPr/>
          <p:nvPr/>
        </p:nvGrpSpPr>
        <p:grpSpPr>
          <a:xfrm>
            <a:off x="5719176" y="3250911"/>
            <a:ext cx="2672583" cy="740972"/>
            <a:chOff x="4112380" y="4613093"/>
            <a:chExt cx="2551634" cy="1218376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A7A6B11B-646E-794E-8F0A-5ADED70737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800" t="41200" r="59665"/>
            <a:stretch/>
          </p:blipFill>
          <p:spPr>
            <a:xfrm>
              <a:off x="4118438" y="4846622"/>
              <a:ext cx="2545576" cy="984847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CA1E2DBE-86AD-8E47-8D43-381612A52A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800" r="60174" b="84176"/>
            <a:stretch/>
          </p:blipFill>
          <p:spPr>
            <a:xfrm>
              <a:off x="4112380" y="4613093"/>
              <a:ext cx="2511070" cy="290668"/>
            </a:xfrm>
            <a:prstGeom prst="rect">
              <a:avLst/>
            </a:prstGeom>
          </p:spPr>
        </p:pic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43EE4FE-C239-C34F-8B55-615FCACDFC88}"/>
              </a:ext>
            </a:extLst>
          </p:cNvPr>
          <p:cNvGrpSpPr/>
          <p:nvPr/>
        </p:nvGrpSpPr>
        <p:grpSpPr>
          <a:xfrm>
            <a:off x="5748739" y="2523124"/>
            <a:ext cx="2658255" cy="727843"/>
            <a:chOff x="4130567" y="3337894"/>
            <a:chExt cx="2613302" cy="1106667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A8738314-0D18-E540-A03C-6606FC8679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8966" t="28686" r="32569"/>
            <a:stretch/>
          </p:blipFill>
          <p:spPr>
            <a:xfrm>
              <a:off x="4130567" y="3644916"/>
              <a:ext cx="2613302" cy="799645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6D1E7E0D-D527-BD43-B1D0-BF97A68768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8966" r="33528" b="85044"/>
            <a:stretch/>
          </p:blipFill>
          <p:spPr>
            <a:xfrm>
              <a:off x="4130567" y="3337894"/>
              <a:ext cx="2561543" cy="303905"/>
            </a:xfrm>
            <a:prstGeom prst="rect">
              <a:avLst/>
            </a:prstGeom>
          </p:spPr>
        </p:pic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9CA4C31-1C46-854E-9844-378545576C92}"/>
              </a:ext>
            </a:extLst>
          </p:cNvPr>
          <p:cNvGrpSpPr/>
          <p:nvPr/>
        </p:nvGrpSpPr>
        <p:grpSpPr>
          <a:xfrm>
            <a:off x="5761439" y="1823213"/>
            <a:ext cx="2551334" cy="750328"/>
            <a:chOff x="4048609" y="824248"/>
            <a:chExt cx="2539573" cy="1247576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D122426-7EEA-8246-9BAB-BC8FAC237F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2918" t="47038" r="38159"/>
            <a:stretch/>
          </p:blipFill>
          <p:spPr>
            <a:xfrm>
              <a:off x="4048609" y="1113755"/>
              <a:ext cx="2536406" cy="958069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AB9B083B-8469-804B-8E5C-82E4A6BAE2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2918" t="2114" r="38158" b="85858"/>
            <a:stretch/>
          </p:blipFill>
          <p:spPr>
            <a:xfrm>
              <a:off x="4051775" y="824248"/>
              <a:ext cx="2536407" cy="247461"/>
            </a:xfrm>
            <a:prstGeom prst="rect">
              <a:avLst/>
            </a:prstGeom>
          </p:spPr>
        </p:pic>
      </p:grpSp>
      <p:sp>
        <p:nvSpPr>
          <p:cNvPr id="29" name="TextBox 4">
            <a:extLst>
              <a:ext uri="{FF2B5EF4-FFF2-40B4-BE49-F238E27FC236}">
                <a16:creationId xmlns:a16="http://schemas.microsoft.com/office/drawing/2014/main" id="{287C6715-7708-CF40-9E84-BB799C1094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08657" y="1489272"/>
            <a:ext cx="47497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3669531-E489-C148-8AFC-77DF88AECD9C}"/>
              </a:ext>
            </a:extLst>
          </p:cNvPr>
          <p:cNvSpPr txBox="1"/>
          <p:nvPr/>
        </p:nvSpPr>
        <p:spPr>
          <a:xfrm rot="16200000">
            <a:off x="5183528" y="1850034"/>
            <a:ext cx="8983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18460C1-241F-7142-BB67-E70D448A9092}"/>
              </a:ext>
            </a:extLst>
          </p:cNvPr>
          <p:cNvSpPr txBox="1"/>
          <p:nvPr/>
        </p:nvSpPr>
        <p:spPr>
          <a:xfrm rot="16200000">
            <a:off x="5347232" y="2742933"/>
            <a:ext cx="558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9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FFB1AF1-C5CA-9D40-A1C8-C7FBECAEA814}"/>
              </a:ext>
            </a:extLst>
          </p:cNvPr>
          <p:cNvSpPr txBox="1"/>
          <p:nvPr/>
        </p:nvSpPr>
        <p:spPr>
          <a:xfrm rot="16200000">
            <a:off x="5310295" y="3428642"/>
            <a:ext cx="632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103282C-914F-7142-991F-D752E5B88547}"/>
              </a:ext>
            </a:extLst>
          </p:cNvPr>
          <p:cNvSpPr txBox="1"/>
          <p:nvPr/>
        </p:nvSpPr>
        <p:spPr>
          <a:xfrm>
            <a:off x="6025555" y="1568687"/>
            <a:ext cx="1752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.131G&gt;A, p. G44D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1CCE1F77-920A-884C-B779-332DBE762386}"/>
              </a:ext>
            </a:extLst>
          </p:cNvPr>
          <p:cNvGrpSpPr/>
          <p:nvPr/>
        </p:nvGrpSpPr>
        <p:grpSpPr>
          <a:xfrm>
            <a:off x="3058500" y="1721711"/>
            <a:ext cx="2240450" cy="770188"/>
            <a:chOff x="6347760" y="310770"/>
            <a:chExt cx="2583391" cy="770188"/>
          </a:xfrm>
        </p:grpSpPr>
        <p:pic>
          <p:nvPicPr>
            <p:cNvPr id="13" name="Picture 12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EB6F1B73-4611-DB47-AC7C-DCAEB3F687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03" t="24969" r="18440" b="9558"/>
            <a:stretch/>
          </p:blipFill>
          <p:spPr>
            <a:xfrm>
              <a:off x="6347760" y="490469"/>
              <a:ext cx="2583391" cy="590489"/>
            </a:xfrm>
            <a:prstGeom prst="rect">
              <a:avLst/>
            </a:prstGeom>
          </p:spPr>
        </p:pic>
        <p:pic>
          <p:nvPicPr>
            <p:cNvPr id="34" name="Picture 33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653774E9-EAB1-A047-9128-67DCDA0293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03" r="18440" b="91407"/>
            <a:stretch/>
          </p:blipFill>
          <p:spPr>
            <a:xfrm>
              <a:off x="6347760" y="310770"/>
              <a:ext cx="2583391" cy="111309"/>
            </a:xfrm>
            <a:prstGeom prst="rect">
              <a:avLst/>
            </a:prstGeom>
          </p:spPr>
        </p:pic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6D3A5E5F-C9ED-574A-8887-AC3A27E44635}"/>
              </a:ext>
            </a:extLst>
          </p:cNvPr>
          <p:cNvGrpSpPr/>
          <p:nvPr/>
        </p:nvGrpSpPr>
        <p:grpSpPr>
          <a:xfrm>
            <a:off x="3080974" y="2503231"/>
            <a:ext cx="2240450" cy="729574"/>
            <a:chOff x="6314949" y="1131045"/>
            <a:chExt cx="2583391" cy="729574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B240347-C311-974D-B3CD-4F4EF20997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307" t="30269" r="19171" b="9257"/>
            <a:stretch/>
          </p:blipFill>
          <p:spPr>
            <a:xfrm>
              <a:off x="6314949" y="1131045"/>
              <a:ext cx="2551678" cy="729574"/>
            </a:xfrm>
            <a:prstGeom prst="rect">
              <a:avLst/>
            </a:prstGeom>
          </p:spPr>
        </p:pic>
        <p:pic>
          <p:nvPicPr>
            <p:cNvPr id="36" name="Picture 35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270BB934-D4B2-C441-9562-246EC6EFEB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03" r="18440" b="91407"/>
            <a:stretch/>
          </p:blipFill>
          <p:spPr>
            <a:xfrm>
              <a:off x="6314949" y="1172395"/>
              <a:ext cx="2583391" cy="111309"/>
            </a:xfrm>
            <a:prstGeom prst="rect">
              <a:avLst/>
            </a:prstGeom>
          </p:spPr>
        </p:pic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9037258E-713F-6240-8737-4B2C320485F9}"/>
              </a:ext>
            </a:extLst>
          </p:cNvPr>
          <p:cNvGrpSpPr/>
          <p:nvPr/>
        </p:nvGrpSpPr>
        <p:grpSpPr>
          <a:xfrm>
            <a:off x="3041208" y="3338169"/>
            <a:ext cx="2240450" cy="696463"/>
            <a:chOff x="6330468" y="1939734"/>
            <a:chExt cx="2583391" cy="696463"/>
          </a:xfrm>
        </p:grpSpPr>
        <p:pic>
          <p:nvPicPr>
            <p:cNvPr id="14" name="Picture 13" descr="A picture containing chart, histogram&#10;&#10;Description automatically generated">
              <a:extLst>
                <a:ext uri="{FF2B5EF4-FFF2-40B4-BE49-F238E27FC236}">
                  <a16:creationId xmlns:a16="http://schemas.microsoft.com/office/drawing/2014/main" id="{3675EF60-06C1-6E4A-A324-E1D7056BBE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427" t="21727" r="20433" b="6198"/>
            <a:stretch/>
          </p:blipFill>
          <p:spPr>
            <a:xfrm>
              <a:off x="6330469" y="1974420"/>
              <a:ext cx="2546226" cy="661777"/>
            </a:xfrm>
            <a:prstGeom prst="rect">
              <a:avLst/>
            </a:prstGeom>
          </p:spPr>
        </p:pic>
        <p:pic>
          <p:nvPicPr>
            <p:cNvPr id="38" name="Picture 37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B9A60C2F-4F46-8B43-9089-9FDB9B18E8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03" r="18440" b="91407"/>
            <a:stretch/>
          </p:blipFill>
          <p:spPr>
            <a:xfrm>
              <a:off x="6330468" y="1939734"/>
              <a:ext cx="2583391" cy="111309"/>
            </a:xfrm>
            <a:prstGeom prst="rect">
              <a:avLst/>
            </a:prstGeom>
          </p:spPr>
        </p:pic>
      </p:grpSp>
      <p:pic>
        <p:nvPicPr>
          <p:cNvPr id="40" name="Picture 39">
            <a:extLst>
              <a:ext uri="{FF2B5EF4-FFF2-40B4-BE49-F238E27FC236}">
                <a16:creationId xmlns:a16="http://schemas.microsoft.com/office/drawing/2014/main" id="{507708FE-FBE8-2544-83AC-77501A5EFDE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775" t="31027" r="11115" b="7284"/>
          <a:stretch/>
        </p:blipFill>
        <p:spPr>
          <a:xfrm>
            <a:off x="317828" y="1899135"/>
            <a:ext cx="2236759" cy="592764"/>
          </a:xfrm>
          <a:prstGeom prst="rect">
            <a:avLst/>
          </a:prstGeom>
        </p:spPr>
      </p:pic>
      <p:grpSp>
        <p:nvGrpSpPr>
          <p:cNvPr id="42" name="Group 41">
            <a:extLst>
              <a:ext uri="{FF2B5EF4-FFF2-40B4-BE49-F238E27FC236}">
                <a16:creationId xmlns:a16="http://schemas.microsoft.com/office/drawing/2014/main" id="{B48A8EE9-FD80-5145-98FC-2DE9E3FB1820}"/>
              </a:ext>
            </a:extLst>
          </p:cNvPr>
          <p:cNvGrpSpPr/>
          <p:nvPr/>
        </p:nvGrpSpPr>
        <p:grpSpPr>
          <a:xfrm>
            <a:off x="317828" y="2543232"/>
            <a:ext cx="2236759" cy="759152"/>
            <a:chOff x="1028452" y="1378820"/>
            <a:chExt cx="2236759" cy="75915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C5A6AB8-829C-4D44-96C1-7FF3CCA3DC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9113" t="36484" r="12008" b="7997"/>
            <a:stretch/>
          </p:blipFill>
          <p:spPr>
            <a:xfrm>
              <a:off x="1028452" y="1457036"/>
              <a:ext cx="2200683" cy="680936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235C3437-02D5-AF45-9AB8-56A01282CF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9775" r="11115" b="84598"/>
            <a:stretch/>
          </p:blipFill>
          <p:spPr>
            <a:xfrm>
              <a:off x="1028452" y="1378820"/>
              <a:ext cx="2236759" cy="203718"/>
            </a:xfrm>
            <a:prstGeom prst="rect">
              <a:avLst/>
            </a:prstGeom>
          </p:spPr>
        </p:pic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949102E7-3341-BA43-A0D1-0F2CB192CB02}"/>
              </a:ext>
            </a:extLst>
          </p:cNvPr>
          <p:cNvGrpSpPr/>
          <p:nvPr/>
        </p:nvGrpSpPr>
        <p:grpSpPr>
          <a:xfrm>
            <a:off x="282389" y="3315329"/>
            <a:ext cx="2271559" cy="731402"/>
            <a:chOff x="1717735" y="3919877"/>
            <a:chExt cx="2271559" cy="73140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EE07933-1BBB-D149-8E6C-6BFDF57E64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9658" t="40530" r="11174" b="6330"/>
            <a:stretch/>
          </p:blipFill>
          <p:spPr>
            <a:xfrm>
              <a:off x="1717735" y="3999525"/>
              <a:ext cx="2271559" cy="651754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5640DE1C-CD7E-5742-9F3C-4FD908D9BB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9775" r="11115" b="84598"/>
            <a:stretch/>
          </p:blipFill>
          <p:spPr>
            <a:xfrm>
              <a:off x="1717735" y="3919877"/>
              <a:ext cx="2236759" cy="203718"/>
            </a:xfrm>
            <a:prstGeom prst="rect">
              <a:avLst/>
            </a:prstGeom>
          </p:spPr>
        </p:pic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2D2264E0-2F8F-2441-BC19-D3D78D233FB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775" r="11115" b="84598"/>
          <a:stretch/>
        </p:blipFill>
        <p:spPr>
          <a:xfrm>
            <a:off x="370568" y="1758383"/>
            <a:ext cx="2236759" cy="203718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9B4FC529-548B-A742-8CCB-04129716EFFB}"/>
              </a:ext>
            </a:extLst>
          </p:cNvPr>
          <p:cNvSpPr txBox="1"/>
          <p:nvPr/>
        </p:nvSpPr>
        <p:spPr>
          <a:xfrm>
            <a:off x="723622" y="1454530"/>
            <a:ext cx="13195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t-MED12 LM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1BC2079-E401-AC41-8636-4F3218DBC9DC}"/>
              </a:ext>
            </a:extLst>
          </p:cNvPr>
          <p:cNvSpPr txBox="1"/>
          <p:nvPr/>
        </p:nvSpPr>
        <p:spPr>
          <a:xfrm>
            <a:off x="3714101" y="146856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E64FAAB-664D-964A-B941-C7B8EDD99AFB}"/>
              </a:ext>
            </a:extLst>
          </p:cNvPr>
          <p:cNvSpPr txBox="1"/>
          <p:nvPr/>
        </p:nvSpPr>
        <p:spPr>
          <a:xfrm>
            <a:off x="6043742" y="1364670"/>
            <a:ext cx="1955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44D mut-MED12 LM</a:t>
            </a:r>
          </a:p>
        </p:txBody>
      </p:sp>
      <p:sp>
        <p:nvSpPr>
          <p:cNvPr id="48" name="TextBox 4">
            <a:extLst>
              <a:ext uri="{FF2B5EF4-FFF2-40B4-BE49-F238E27FC236}">
                <a16:creationId xmlns:a16="http://schemas.microsoft.com/office/drawing/2014/main" id="{8F2599AF-8921-FB44-925A-DDCE5114B9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8028" y="1426165"/>
            <a:ext cx="47497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4C47C77-784A-E942-9FFE-CC1CD16EFEE7}"/>
              </a:ext>
            </a:extLst>
          </p:cNvPr>
          <p:cNvSpPr/>
          <p:nvPr/>
        </p:nvSpPr>
        <p:spPr>
          <a:xfrm>
            <a:off x="7714039" y="1833020"/>
            <a:ext cx="218843" cy="2158864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B7DD6653-EED8-864D-BA68-DBA89091AA8B}"/>
              </a:ext>
            </a:extLst>
          </p:cNvPr>
          <p:cNvGrpSpPr/>
          <p:nvPr/>
        </p:nvGrpSpPr>
        <p:grpSpPr>
          <a:xfrm>
            <a:off x="8840705" y="3232178"/>
            <a:ext cx="2493666" cy="746454"/>
            <a:chOff x="357164" y="650481"/>
            <a:chExt cx="2554890" cy="1201650"/>
          </a:xfrm>
        </p:grpSpPr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1E51DE43-D53C-284B-B692-3473122861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1102" t="35386" r="36168"/>
            <a:stretch/>
          </p:blipFill>
          <p:spPr>
            <a:xfrm>
              <a:off x="357164" y="929537"/>
              <a:ext cx="2523300" cy="922594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1D68F4D5-EDCF-C446-B603-B5631F2F1E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1101" r="35634" b="86038"/>
            <a:stretch/>
          </p:blipFill>
          <p:spPr>
            <a:xfrm>
              <a:off x="357164" y="650481"/>
              <a:ext cx="2554890" cy="226465"/>
            </a:xfrm>
            <a:prstGeom prst="rect">
              <a:avLst/>
            </a:prstGeom>
          </p:spPr>
        </p:pic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634BB805-1F9E-A840-A96F-BF1EFFB01031}"/>
              </a:ext>
            </a:extLst>
          </p:cNvPr>
          <p:cNvGrpSpPr/>
          <p:nvPr/>
        </p:nvGrpSpPr>
        <p:grpSpPr>
          <a:xfrm>
            <a:off x="8834886" y="2523124"/>
            <a:ext cx="2468652" cy="713751"/>
            <a:chOff x="357164" y="650479"/>
            <a:chExt cx="2529262" cy="1201652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33C71FE7-53D2-C945-9B15-D94FFE37CD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1102" t="35386" r="36067"/>
            <a:stretch/>
          </p:blipFill>
          <p:spPr>
            <a:xfrm>
              <a:off x="357164" y="929536"/>
              <a:ext cx="2529262" cy="922595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FCE5C8B0-3955-3645-AF6E-C955B603FB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1100" r="36068" b="82796"/>
            <a:stretch/>
          </p:blipFill>
          <p:spPr>
            <a:xfrm>
              <a:off x="357164" y="650479"/>
              <a:ext cx="2529262" cy="279057"/>
            </a:xfrm>
            <a:prstGeom prst="rect">
              <a:avLst/>
            </a:prstGeom>
          </p:spPr>
        </p:pic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E9089D32-5E16-CF4E-AB01-4F4A951D6047}"/>
              </a:ext>
            </a:extLst>
          </p:cNvPr>
          <p:cNvGrpSpPr/>
          <p:nvPr/>
        </p:nvGrpSpPr>
        <p:grpSpPr>
          <a:xfrm>
            <a:off x="8815789" y="1811897"/>
            <a:ext cx="2494100" cy="719038"/>
            <a:chOff x="363670" y="694616"/>
            <a:chExt cx="2555335" cy="1157515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3DDF8254-46DA-E24D-8A4C-3ADD7FF781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1103" t="35386" r="35626"/>
            <a:stretch/>
          </p:blipFill>
          <p:spPr>
            <a:xfrm>
              <a:off x="363670" y="929537"/>
              <a:ext cx="2555335" cy="922594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4E037D19-EF16-B744-A412-4F8B860E52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1101" t="2721" r="35626" b="86431"/>
            <a:stretch/>
          </p:blipFill>
          <p:spPr>
            <a:xfrm>
              <a:off x="363670" y="694616"/>
              <a:ext cx="2555335" cy="175957"/>
            </a:xfrm>
            <a:prstGeom prst="rect">
              <a:avLst/>
            </a:prstGeom>
          </p:spPr>
        </p:pic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142DFC9C-4B91-2B4F-8502-A0F8CC8E8954}"/>
              </a:ext>
            </a:extLst>
          </p:cNvPr>
          <p:cNvSpPr txBox="1"/>
          <p:nvPr/>
        </p:nvSpPr>
        <p:spPr>
          <a:xfrm rot="16200000">
            <a:off x="8271371" y="1939870"/>
            <a:ext cx="8983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0FF7362-5BC7-A74F-A1FC-82D80EDC86FC}"/>
              </a:ext>
            </a:extLst>
          </p:cNvPr>
          <p:cNvSpPr txBox="1"/>
          <p:nvPr/>
        </p:nvSpPr>
        <p:spPr>
          <a:xfrm rot="16200000">
            <a:off x="8265004" y="2599200"/>
            <a:ext cx="8983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63246E3-D3C5-914A-8E03-935D2ECF773E}"/>
              </a:ext>
            </a:extLst>
          </p:cNvPr>
          <p:cNvSpPr txBox="1"/>
          <p:nvPr/>
        </p:nvSpPr>
        <p:spPr>
          <a:xfrm rot="16200000">
            <a:off x="8265005" y="3316441"/>
            <a:ext cx="8983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T 7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5926EE6D-EC05-3241-B8E3-4F71FA9B5E66}"/>
              </a:ext>
            </a:extLst>
          </p:cNvPr>
          <p:cNvSpPr/>
          <p:nvPr/>
        </p:nvSpPr>
        <p:spPr>
          <a:xfrm>
            <a:off x="10702220" y="1823212"/>
            <a:ext cx="231419" cy="2168671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4ED5054-6248-EA4C-BACA-D398B528DD2C}"/>
              </a:ext>
            </a:extLst>
          </p:cNvPr>
          <p:cNvSpPr txBox="1"/>
          <p:nvPr/>
        </p:nvSpPr>
        <p:spPr>
          <a:xfrm>
            <a:off x="8928410" y="1555327"/>
            <a:ext cx="1752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.131G&gt;A, p. G44D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16DB5DB-FEF5-DF44-9F51-C0BB8D5660DE}"/>
              </a:ext>
            </a:extLst>
          </p:cNvPr>
          <p:cNvSpPr txBox="1"/>
          <p:nvPr/>
        </p:nvSpPr>
        <p:spPr>
          <a:xfrm>
            <a:off x="8946597" y="1351310"/>
            <a:ext cx="1955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44D mut-MED12 LM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4BBE034D-D658-C943-B8D4-6D2DCD1DDBB5}"/>
              </a:ext>
            </a:extLst>
          </p:cNvPr>
          <p:cNvSpPr/>
          <p:nvPr/>
        </p:nvSpPr>
        <p:spPr>
          <a:xfrm>
            <a:off x="9227" y="-180944"/>
            <a:ext cx="2659702" cy="5604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79685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FA35113-A9FC-A04A-B547-61ECB75373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2109" y="1524155"/>
            <a:ext cx="4522810" cy="305899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FC8DB29-6575-3D40-BB7E-3AF249EB35A0}"/>
              </a:ext>
            </a:extLst>
          </p:cNvPr>
          <p:cNvSpPr/>
          <p:nvPr/>
        </p:nvSpPr>
        <p:spPr>
          <a:xfrm>
            <a:off x="0" y="-178420"/>
            <a:ext cx="2659702" cy="5604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F261FE-5D7B-7E4F-B1FD-25EAAF0063E9}"/>
              </a:ext>
            </a:extLst>
          </p:cNvPr>
          <p:cNvSpPr txBox="1"/>
          <p:nvPr/>
        </p:nvSpPr>
        <p:spPr>
          <a:xfrm rot="16200000">
            <a:off x="2166759" y="3051606"/>
            <a:ext cx="18375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DO2 mRNA levels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7635B2D-85A0-474B-B28C-F6C9E447DCA3}"/>
              </a:ext>
            </a:extLst>
          </p:cNvPr>
          <p:cNvSpPr/>
          <p:nvPr/>
        </p:nvSpPr>
        <p:spPr>
          <a:xfrm>
            <a:off x="8129239" y="2465128"/>
            <a:ext cx="579863" cy="23417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9B69A86-73C9-E94A-94C1-0464610EECE1}"/>
              </a:ext>
            </a:extLst>
          </p:cNvPr>
          <p:cNvSpPr/>
          <p:nvPr/>
        </p:nvSpPr>
        <p:spPr>
          <a:xfrm>
            <a:off x="8129239" y="2819478"/>
            <a:ext cx="579863" cy="234175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792EBE-6E76-664B-9F49-4869AD2E846E}"/>
              </a:ext>
            </a:extLst>
          </p:cNvPr>
          <p:cNvSpPr txBox="1"/>
          <p:nvPr/>
        </p:nvSpPr>
        <p:spPr>
          <a:xfrm>
            <a:off x="8653129" y="2390059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599DA26-0F59-FA44-A798-4949FBC5CEDF}"/>
              </a:ext>
            </a:extLst>
          </p:cNvPr>
          <p:cNvSpPr txBox="1"/>
          <p:nvPr/>
        </p:nvSpPr>
        <p:spPr>
          <a:xfrm>
            <a:off x="8697517" y="2738870"/>
            <a:ext cx="570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P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8B3B041-C89B-8D49-93B3-E856BEBA2881}"/>
              </a:ext>
            </a:extLst>
          </p:cNvPr>
          <p:cNvSpPr txBox="1"/>
          <p:nvPr/>
        </p:nvSpPr>
        <p:spPr>
          <a:xfrm>
            <a:off x="3820717" y="444933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 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795E71-C63F-734C-AA9F-BFCFA5314E47}"/>
              </a:ext>
            </a:extLst>
          </p:cNvPr>
          <p:cNvSpPr txBox="1"/>
          <p:nvPr/>
        </p:nvSpPr>
        <p:spPr>
          <a:xfrm>
            <a:off x="4832913" y="4449339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9190D41-48ED-2F48-92FE-C9B414C90E6C}"/>
              </a:ext>
            </a:extLst>
          </p:cNvPr>
          <p:cNvSpPr txBox="1"/>
          <p:nvPr/>
        </p:nvSpPr>
        <p:spPr>
          <a:xfrm>
            <a:off x="5899892" y="4471641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63316F5-E91A-DC4C-AE89-34A898EC881A}"/>
              </a:ext>
            </a:extLst>
          </p:cNvPr>
          <p:cNvSpPr txBox="1"/>
          <p:nvPr/>
        </p:nvSpPr>
        <p:spPr>
          <a:xfrm>
            <a:off x="7011475" y="4449339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72 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B725C07-E0D3-C447-B2E5-9316CEF0AA21}"/>
              </a:ext>
            </a:extLst>
          </p:cNvPr>
          <p:cNvSpPr txBox="1"/>
          <p:nvPr/>
        </p:nvSpPr>
        <p:spPr>
          <a:xfrm>
            <a:off x="4128111" y="2755247"/>
            <a:ext cx="225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2EED8A9-F3D5-574A-A424-27B0D259F544}"/>
              </a:ext>
            </a:extLst>
          </p:cNvPr>
          <p:cNvSpPr txBox="1"/>
          <p:nvPr/>
        </p:nvSpPr>
        <p:spPr>
          <a:xfrm>
            <a:off x="5170550" y="2891425"/>
            <a:ext cx="225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828E7D4-F9FC-FB41-9AA2-61A2F3183F92}"/>
              </a:ext>
            </a:extLst>
          </p:cNvPr>
          <p:cNvSpPr txBox="1"/>
          <p:nvPr/>
        </p:nvSpPr>
        <p:spPr>
          <a:xfrm>
            <a:off x="6230851" y="2738870"/>
            <a:ext cx="225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D9F0B4B-06B6-0745-9BA2-D52019A8BAAB}"/>
              </a:ext>
            </a:extLst>
          </p:cNvPr>
          <p:cNvSpPr txBox="1"/>
          <p:nvPr/>
        </p:nvSpPr>
        <p:spPr>
          <a:xfrm>
            <a:off x="7209144" y="3587871"/>
            <a:ext cx="5019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2284786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5</TotalTime>
  <Words>78</Words>
  <Application>Microsoft Macintosh PowerPoint</Application>
  <PresentationFormat>Widescreen</PresentationFormat>
  <Paragraphs>3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FIGURES (TDO2)</dc:title>
  <dc:creator>Anne Hutchinson</dc:creator>
  <cp:lastModifiedBy>Anne Hutchinson</cp:lastModifiedBy>
  <cp:revision>70</cp:revision>
  <dcterms:created xsi:type="dcterms:W3CDTF">2020-12-17T16:25:06Z</dcterms:created>
  <dcterms:modified xsi:type="dcterms:W3CDTF">2021-12-07T17:52:15Z</dcterms:modified>
</cp:coreProperties>
</file>